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40" autoAdjust="0"/>
    <p:restoredTop sz="94660"/>
  </p:normalViewPr>
  <p:slideViewPr>
    <p:cSldViewPr snapToGrid="0">
      <p:cViewPr varScale="1">
        <p:scale>
          <a:sx n="78" d="100"/>
          <a:sy n="78" d="100"/>
        </p:scale>
        <p:origin x="288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9030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9316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0814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6929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1662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6777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8036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2114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5166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4651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3364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7DC23A-04BB-4151-B697-FE2C7C94F2A3}" type="datetimeFigureOut">
              <a:rPr lang="fr-FR" smtClean="0"/>
              <a:t>18/1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0C5F0-5A33-42EB-B91F-760A5E0F8F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4005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6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7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cid:image001.png@01D9715D.05AD21F0" TargetMode="External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cid:image002.png@01D9715D.05AD21F0" TargetMode="Externa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0746211"/>
              </p:ext>
            </p:extLst>
          </p:nvPr>
        </p:nvGraphicFramePr>
        <p:xfrm>
          <a:off x="1163546" y="3090646"/>
          <a:ext cx="1887220" cy="22631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27380">
                  <a:extLst>
                    <a:ext uri="{9D8B030D-6E8A-4147-A177-3AD203B41FA5}">
                      <a16:colId xmlns:a16="http://schemas.microsoft.com/office/drawing/2014/main" val="3026030250"/>
                    </a:ext>
                  </a:extLst>
                </a:gridCol>
                <a:gridCol w="1259840">
                  <a:extLst>
                    <a:ext uri="{9D8B030D-6E8A-4147-A177-3AD203B41FA5}">
                      <a16:colId xmlns:a16="http://schemas.microsoft.com/office/drawing/2014/main" val="196189756"/>
                    </a:ext>
                  </a:extLst>
                </a:gridCol>
              </a:tblGrid>
              <a:tr h="3619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Year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Number of patient’s file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59826608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2003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100 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20043580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2004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269 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75305908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2005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242 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27468015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2006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354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2545201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2007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408 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17527321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2008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480 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23296197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2009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621 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96081857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2010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634 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93387607"/>
                  </a:ext>
                </a:extLst>
              </a:tr>
              <a:tr h="36195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>
                          <a:effectLst/>
                        </a:rPr>
                        <a:t>2011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900" dirty="0">
                          <a:effectLst/>
                        </a:rPr>
                        <a:t>401 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07123233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164181" y="2268567"/>
            <a:ext cx="5779146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Table </a:t>
            </a: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1</a:t>
            </a: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Number of patients’ files collected over the years of study</a:t>
            </a:r>
            <a:endParaRPr kumimoji="0" lang="fr-FR" alt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6382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/>
        </p:nvGraphicFramePr>
        <p:xfrm>
          <a:off x="519113" y="4459343"/>
          <a:ext cx="6521451" cy="355747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786095">
                  <a:extLst>
                    <a:ext uri="{9D8B030D-6E8A-4147-A177-3AD203B41FA5}">
                      <a16:colId xmlns:a16="http://schemas.microsoft.com/office/drawing/2014/main" val="1401816730"/>
                    </a:ext>
                  </a:extLst>
                </a:gridCol>
                <a:gridCol w="2786095">
                  <a:extLst>
                    <a:ext uri="{9D8B030D-6E8A-4147-A177-3AD203B41FA5}">
                      <a16:colId xmlns:a16="http://schemas.microsoft.com/office/drawing/2014/main" val="719749484"/>
                    </a:ext>
                  </a:extLst>
                </a:gridCol>
                <a:gridCol w="949261">
                  <a:extLst>
                    <a:ext uri="{9D8B030D-6E8A-4147-A177-3AD203B41FA5}">
                      <a16:colId xmlns:a16="http://schemas.microsoft.com/office/drawing/2014/main" val="3633574018"/>
                    </a:ext>
                  </a:extLst>
                </a:gridCol>
              </a:tblGrid>
              <a:tr h="71149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Exposure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otal cases</a:t>
                      </a:r>
                      <a:endParaRPr lang="fr-FR" sz="1100">
                        <a:effectLst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n/n examined</a:t>
                      </a:r>
                      <a:endParaRPr lang="fr-FR" sz="1100">
                        <a:effectLst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(%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3893197142"/>
                  </a:ext>
                </a:extLst>
              </a:tr>
              <a:tr h="237165">
                <a:tc rowSpan="5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ccupational risk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73 (10.8%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3801830156"/>
                  </a:ext>
                </a:extLst>
              </a:tr>
              <a:tr h="23716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Farmer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63%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2052867246"/>
                  </a:ext>
                </a:extLst>
              </a:tr>
              <a:tr h="23716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anger/ tree faller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3.6%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1750183385"/>
                  </a:ext>
                </a:extLst>
              </a:tr>
              <a:tr h="23716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etired farmer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8%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2002269888"/>
                  </a:ext>
                </a:extLst>
              </a:tr>
              <a:tr h="474331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ther agricultural representative, roadworks, garden maintenance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1.6%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2647215357"/>
                  </a:ext>
                </a:extLst>
              </a:tr>
              <a:tr h="237165">
                <a:tc rowSpan="6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ecreational risk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976 (96.8%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2248613842"/>
                  </a:ext>
                </a:extLst>
              </a:tr>
              <a:tr h="23716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Hiking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1.9%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3191745968"/>
                  </a:ext>
                </a:extLst>
              </a:tr>
              <a:tr h="23716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Hunting, fishing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6%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4078203569"/>
                  </a:ext>
                </a:extLst>
              </a:tr>
              <a:tr h="23716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Walking in the forest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69.5%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2640915645"/>
                  </a:ext>
                </a:extLst>
              </a:tr>
              <a:tr h="23716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ther outdoor activitie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2%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2444168380"/>
                  </a:ext>
                </a:extLst>
              </a:tr>
              <a:tr h="23716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Unspecified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6%</a:t>
                      </a:r>
                      <a:endParaRPr lang="fr-FR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81" marR="64681" marT="0" marB="0"/>
                </a:tc>
                <a:extLst>
                  <a:ext uri="{0D108BD9-81ED-4DB2-BD59-A6C34878D82A}">
                    <a16:rowId xmlns:a16="http://schemas.microsoft.com/office/drawing/2014/main" val="2746258616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519113" y="4459288"/>
            <a:ext cx="755967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4" name="Rectangle 3"/>
          <p:cNvSpPr/>
          <p:nvPr/>
        </p:nvSpPr>
        <p:spPr>
          <a:xfrm>
            <a:off x="216869" y="2155524"/>
            <a:ext cx="682369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Table 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2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Exposure to occupational and recreational risks of the population </a:t>
            </a:r>
            <a:endParaRPr lang="fr-FR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7326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/>
        </p:nvGraphicFramePr>
        <p:xfrm>
          <a:off x="1347787" y="4523581"/>
          <a:ext cx="4864101" cy="34290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79820">
                  <a:extLst>
                    <a:ext uri="{9D8B030D-6E8A-4147-A177-3AD203B41FA5}">
                      <a16:colId xmlns:a16="http://schemas.microsoft.com/office/drawing/2014/main" val="2748633768"/>
                    </a:ext>
                  </a:extLst>
                </a:gridCol>
                <a:gridCol w="2545442">
                  <a:extLst>
                    <a:ext uri="{9D8B030D-6E8A-4147-A177-3AD203B41FA5}">
                      <a16:colId xmlns:a16="http://schemas.microsoft.com/office/drawing/2014/main" val="2384022832"/>
                    </a:ext>
                  </a:extLst>
                </a:gridCol>
                <a:gridCol w="1438839">
                  <a:extLst>
                    <a:ext uri="{9D8B030D-6E8A-4147-A177-3AD203B41FA5}">
                      <a16:colId xmlns:a16="http://schemas.microsoft.com/office/drawing/2014/main" val="4269250001"/>
                    </a:ext>
                  </a:extLst>
                </a:gridCol>
              </a:tblGrid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Neurological manifestation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n /n examined secondary phase (%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53+95* (57.8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748428806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 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Facial palsy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3+17* (12.1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4032610293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Facial palsy + Meningeal symptom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53+23* (30.6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98356002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Facial palsy + Meningoradiculoneuriti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9+7* (10.5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857338909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Facial palsy + Radiculiti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  (0.4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452985765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Facial palsy + Meningeal symptoms + uveitis  or keratiti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5*  (2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956226415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Meningoradiculoneuriti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21+19* (16.1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741713884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Radiculitis 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8+9* (10.9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709205504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Meningeal symptom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3+12* (10.1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663831944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Meningeal symptoms + AVB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  (0.4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99776489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Meningeal symptoms + uveitis 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  (0.4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936984620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Diplopia palsy VI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2+2* (5.6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951819291"/>
                  </a:ext>
                </a:extLst>
              </a:tr>
              <a:tr h="100330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 unspecified peripheral neurological symptom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</a:rPr>
                        <a:t>1+1* (0.8)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565396689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691376" y="2623874"/>
            <a:ext cx="631159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Table 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3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Neurological manifestations of the early disseminated  phase (*:EM)</a:t>
            </a:r>
            <a:endParaRPr lang="fr-FR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17297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/>
        </p:nvGraphicFramePr>
        <p:xfrm>
          <a:off x="1131521" y="2351882"/>
          <a:ext cx="5296634" cy="77724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55217">
                  <a:extLst>
                    <a:ext uri="{9D8B030D-6E8A-4147-A177-3AD203B41FA5}">
                      <a16:colId xmlns:a16="http://schemas.microsoft.com/office/drawing/2014/main" val="106656960"/>
                    </a:ext>
                  </a:extLst>
                </a:gridCol>
                <a:gridCol w="2287266">
                  <a:extLst>
                    <a:ext uri="{9D8B030D-6E8A-4147-A177-3AD203B41FA5}">
                      <a16:colId xmlns:a16="http://schemas.microsoft.com/office/drawing/2014/main" val="2662786160"/>
                    </a:ext>
                  </a:extLst>
                </a:gridCol>
                <a:gridCol w="2154151">
                  <a:extLst>
                    <a:ext uri="{9D8B030D-6E8A-4147-A177-3AD203B41FA5}">
                      <a16:colId xmlns:a16="http://schemas.microsoft.com/office/drawing/2014/main" val="3973754538"/>
                    </a:ext>
                  </a:extLst>
                </a:gridCol>
              </a:tblGrid>
              <a:tr h="437638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Rheumatoid  manifestation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n /n examined secondary phase (%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03+4* (5.1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2957893892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only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99 (92.5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2669681834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 Arthritis with confirmed  EM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4  (3.7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3477034503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 Arthritis  with  probable EM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2  (1.9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3119823642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 Arthritis  with  confirmed uveiti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  (0.9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2084390825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 Arthritis  with doubtful neuroborreliosi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  (0.9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3332165614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Monoarthritis  or Oligoarthtriti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73/12  (79.4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348118794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Polyarthriti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9  (8.4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1340051237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unspecified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3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3322296852"/>
                  </a:ext>
                </a:extLst>
              </a:tr>
              <a:tr h="656457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Borrelial lymphocytoma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29 (6.8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170794604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only/ with probable neuroborreliosi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28/1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3662280463"/>
                  </a:ext>
                </a:extLst>
              </a:tr>
              <a:tr h="437638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Cardiac manifestation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8+3* (4.9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2432713113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only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7 (81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4241072843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with  confirmed neuroborreliosi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 (4.8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607573450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with  confirmed EM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3* (14.3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3142076896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Conduction defect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4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2954205393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Myocarditi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4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215273799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Pericarditi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2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4138843308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other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546402447"/>
                  </a:ext>
                </a:extLst>
              </a:tr>
              <a:tr h="437638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Occular manifestation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21+3* (5.6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546185564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Uveitis only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5 (62.5)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1137580161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Uveitis with  confirmed  neuroborreliosi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+2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2878686226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Uveitis with  doubtful neuroborreliosi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2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1267469250"/>
                  </a:ext>
                </a:extLst>
              </a:tr>
              <a:tr h="218819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Uveitis with  confirmed arthritis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1158910167"/>
                  </a:ext>
                </a:extLst>
              </a:tr>
              <a:tr h="437638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keratitis with  confirmed neuroborreliosis and EM</a:t>
                      </a:r>
                      <a:endParaRPr lang="fr-FR" sz="1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</a:rPr>
                        <a:t>3</a:t>
                      </a:r>
                      <a:endParaRPr lang="fr-FR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2548" marR="42548" marT="0" marB="0" anchor="ctr"/>
                </a:tc>
                <a:extLst>
                  <a:ext uri="{0D108BD9-81ED-4DB2-BD59-A6C34878D82A}">
                    <a16:rowId xmlns:a16="http://schemas.microsoft.com/office/drawing/2014/main" val="3705717540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1131888" y="2352675"/>
            <a:ext cx="755967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4" name="Rectangle 3"/>
          <p:cNvSpPr/>
          <p:nvPr/>
        </p:nvSpPr>
        <p:spPr>
          <a:xfrm>
            <a:off x="758283" y="779799"/>
            <a:ext cx="566987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Table 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4</a:t>
            </a: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ther symptoms of the early disseminated  phase (*:EM)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2326172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/>
        </p:nvGraphicFramePr>
        <p:xfrm>
          <a:off x="1482725" y="4752181"/>
          <a:ext cx="4594225" cy="29718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32889">
                  <a:extLst>
                    <a:ext uri="{9D8B030D-6E8A-4147-A177-3AD203B41FA5}">
                      <a16:colId xmlns:a16="http://schemas.microsoft.com/office/drawing/2014/main" val="4151888092"/>
                    </a:ext>
                  </a:extLst>
                </a:gridCol>
                <a:gridCol w="2161279">
                  <a:extLst>
                    <a:ext uri="{9D8B030D-6E8A-4147-A177-3AD203B41FA5}">
                      <a16:colId xmlns:a16="http://schemas.microsoft.com/office/drawing/2014/main" val="4186204879"/>
                    </a:ext>
                  </a:extLst>
                </a:gridCol>
                <a:gridCol w="900057">
                  <a:extLst>
                    <a:ext uri="{9D8B030D-6E8A-4147-A177-3AD203B41FA5}">
                      <a16:colId xmlns:a16="http://schemas.microsoft.com/office/drawing/2014/main" val="1007569430"/>
                    </a:ext>
                  </a:extLst>
                </a:gridCol>
              </a:tblGrid>
              <a:tr h="158115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Acrodermatitis chronica atrophican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n /n examined late disseminated phase (%)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36 (50.7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407245289"/>
                  </a:ext>
                </a:extLst>
              </a:tr>
              <a:tr h="158115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Only/ with  doubtful neuroborreliosi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34/2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439064350"/>
                  </a:ext>
                </a:extLst>
              </a:tr>
              <a:tr h="158115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Chronic Arthritis  manifestation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31 (43.7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392407302"/>
                  </a:ext>
                </a:extLst>
              </a:tr>
              <a:tr h="158115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only / with  probable  EM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29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276133413"/>
                  </a:ext>
                </a:extLst>
              </a:tr>
              <a:tr h="158115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 with probable neuroborreliosis / doubtful neuroborreliosi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1/1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3697212189"/>
                  </a:ext>
                </a:extLst>
              </a:tr>
              <a:tr h="158115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Monoarthritis  or Oligoarthtriti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21/3 (92.3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1382096755"/>
                  </a:ext>
                </a:extLst>
              </a:tr>
              <a:tr h="158115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Polyarthriti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2 (7.7)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2135059870"/>
                  </a:ext>
                </a:extLst>
              </a:tr>
              <a:tr h="158115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unspecified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5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681650053"/>
                  </a:ext>
                </a:extLst>
              </a:tr>
              <a:tr h="158115"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Neurological manifestations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>
                          <a:effectLst/>
                        </a:rPr>
                        <a:t>Meningoencephalitis, polyneuropathy, cerebellar syndrome</a:t>
                      </a:r>
                      <a:endParaRPr lang="fr-FR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fr-FR" sz="1000" dirty="0">
                          <a:effectLst/>
                        </a:rPr>
                        <a:t>3/1/0(5.6)</a:t>
                      </a:r>
                      <a:endParaRPr lang="fr-FR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/>
                </a:tc>
                <a:extLst>
                  <a:ext uri="{0D108BD9-81ED-4DB2-BD59-A6C34878D82A}">
                    <a16:rowId xmlns:a16="http://schemas.microsoft.com/office/drawing/2014/main" val="72900373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092820" y="2943136"/>
            <a:ext cx="541949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Table 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5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ymptoms of the late disseminated  phase</a:t>
            </a:r>
            <a:endParaRPr lang="fr-FR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34814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0"/>
          <p:cNvSpPr>
            <a:spLocks noChangeArrowheads="1"/>
          </p:cNvSpPr>
          <p:nvPr/>
        </p:nvSpPr>
        <p:spPr bwMode="auto">
          <a:xfrm>
            <a:off x="47797" y="373080"/>
            <a:ext cx="7563289" cy="12311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1:</a:t>
            </a:r>
            <a:r>
              <a:rPr kumimoji="0" lang="en-US" altLang="fr-F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haracterization of the patients’ cases</a:t>
            </a: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fr-FR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CA projection of patients on dimensions 1 (x-axis) and 2 (y-axis), showing the A: case repartition as function of age: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16 years: orange; &gt;16 years: grey. B: Notion of tick bite in the case population: yes: orange, grey: no. C: Sankey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lot showing the tick bite localization as function of age.</a:t>
            </a:r>
            <a:endParaRPr kumimoji="0" lang="fr-FR" altLang="fr-FR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3" name="Groupe 2"/>
          <p:cNvGrpSpPr/>
          <p:nvPr/>
        </p:nvGrpSpPr>
        <p:grpSpPr>
          <a:xfrm>
            <a:off x="685800" y="1809750"/>
            <a:ext cx="6409055" cy="5704205"/>
            <a:chOff x="0" y="0"/>
            <a:chExt cx="6409346" cy="5704265"/>
          </a:xfrm>
        </p:grpSpPr>
        <p:sp>
          <p:nvSpPr>
            <p:cNvPr id="4" name="ZoneTexte 12"/>
            <p:cNvSpPr txBox="1"/>
            <p:nvPr/>
          </p:nvSpPr>
          <p:spPr>
            <a:xfrm>
              <a:off x="244498" y="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fr-FR" sz="1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fr-FR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pic>
          <p:nvPicPr>
            <p:cNvPr id="5" name="Image 4" descr="X:\Valerie CNR\2020\article Elisabeth VALERIE\article octobre 2020\RECAP ARTICLE CAS HUMAIN  FICHIER MAI 2022\RECAP FIGURE TABLEAU JANVIER\envoi 5\Dim12\fig_age.tiff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6242" y="413900"/>
              <a:ext cx="2667000" cy="233518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6" name="Image 5" descr="C:\Users\eferquel\AppData\Local\Microsoft\Windows\INetCache\Content.Word\fig_present_bite.tiff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96186" y="458468"/>
              <a:ext cx="2667000" cy="228959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" name="Image 6"/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79742" y="273170"/>
              <a:ext cx="1590675" cy="530225"/>
            </a:xfrm>
            <a:prstGeom prst="rect">
              <a:avLst/>
            </a:prstGeom>
          </p:spPr>
        </p:pic>
        <p:pic>
          <p:nvPicPr>
            <p:cNvPr id="8" name="Image 7" descr="C:\Users\eferquel\AppData\Local\Microsoft\Windows\INetCache\Content.Word\fig_leasure_risk_legend.tiff"/>
            <p:cNvPicPr/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47941" y="0"/>
              <a:ext cx="1861405" cy="853878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" name="ZoneTexte 14"/>
            <p:cNvSpPr txBox="1"/>
            <p:nvPr/>
          </p:nvSpPr>
          <p:spPr>
            <a:xfrm>
              <a:off x="3394442" y="26980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fr-FR" sz="1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fr-FR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pic>
          <p:nvPicPr>
            <p:cNvPr id="10" name="Image 9"/>
            <p:cNvPicPr/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255705"/>
              <a:ext cx="3143785" cy="2448560"/>
            </a:xfrm>
            <a:prstGeom prst="rect">
              <a:avLst/>
            </a:prstGeom>
          </p:spPr>
        </p:pic>
        <p:sp>
          <p:nvSpPr>
            <p:cNvPr id="11" name="ZoneTexte 25"/>
            <p:cNvSpPr txBox="1"/>
            <p:nvPr/>
          </p:nvSpPr>
          <p:spPr>
            <a:xfrm>
              <a:off x="236156" y="2878558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fr-FR" sz="18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fr-FR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12" name="Rectangle 14"/>
          <p:cNvSpPr>
            <a:spLocks noChangeArrowheads="1"/>
          </p:cNvSpPr>
          <p:nvPr/>
        </p:nvSpPr>
        <p:spPr bwMode="auto">
          <a:xfrm>
            <a:off x="0" y="457200"/>
            <a:ext cx="7559675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05547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12234" y="1797239"/>
            <a:ext cx="7253909" cy="8771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</a:t>
            </a: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2</a:t>
            </a: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MCA projection of systemic symptoms on dimensions 1 (x-axis) and 2 (y-axis)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 systemic symptom is represented by the gravity center of patients having this symptom, in the space computed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by the MCA</a:t>
            </a:r>
            <a:endParaRPr kumimoji="0" lang="fr-FR" alt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3" name="Obje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0847813"/>
              </p:ext>
            </p:extLst>
          </p:nvPr>
        </p:nvGraphicFramePr>
        <p:xfrm>
          <a:off x="312234" y="3111190"/>
          <a:ext cx="5762625" cy="5762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6" r:id="rId3" imgW="18642751" imgH="18663557" progId="Unknown">
                  <p:embed/>
                </p:oleObj>
              </mc:Choice>
              <mc:Fallback>
                <p:oleObj r:id="rId3" imgW="18642751" imgH="18663557" progId="Unknown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2234" y="3111190"/>
                        <a:ext cx="5762625" cy="57626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790480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9826047"/>
              </p:ext>
            </p:extLst>
          </p:nvPr>
        </p:nvGraphicFramePr>
        <p:xfrm>
          <a:off x="512956" y="2259459"/>
          <a:ext cx="3695700" cy="3695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7" r:id="rId3" imgW="18642751" imgH="18663557" progId="Unknown">
                  <p:embed/>
                </p:oleObj>
              </mc:Choice>
              <mc:Fallback>
                <p:oleObj r:id="rId3" imgW="18642751" imgH="18663557" progId="Unknown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2956" y="2259459"/>
                        <a:ext cx="3695700" cy="36957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3329586"/>
              </p:ext>
            </p:extLst>
          </p:nvPr>
        </p:nvGraphicFramePr>
        <p:xfrm>
          <a:off x="0" y="6632184"/>
          <a:ext cx="5762625" cy="2886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8" r:id="rId5" imgW="18642751" imgH="9331779" progId="Unknown">
                  <p:embed/>
                </p:oleObj>
              </mc:Choice>
              <mc:Fallback>
                <p:oleObj r:id="rId5" imgW="18642751" imgH="9331779" progId="Unknown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0" y="6632184"/>
                        <a:ext cx="5762625" cy="28860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0" y="814100"/>
            <a:ext cx="7420621" cy="32932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</a:t>
            </a: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3</a:t>
            </a: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Characteristic of cutaneous manifestations.</a:t>
            </a: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: MCA projection of the cutaneous manifestations on dimensions 1 (x-axis) and 2 (y-axis)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 cutaneous manifestation is represented by the gravity center of patients having this symptom,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n the space computed by the MCA. B: Sankey plot showing the association between dermatological symptoms and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spectively, gender and systemic symptoms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lang="en-US" altLang="fr-FR" sz="1100" dirty="0"/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kumimoji="0" lang="fr-FR" alt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kumimoji="0" lang="fr-FR" altLang="fr-FR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lang="fr-FR" altLang="fr-FR" sz="1200" dirty="0" smtClean="0">
                <a:ea typeface="Times New Roman" panose="02020603050405020304" pitchFamily="18" charset="0"/>
              </a:rPr>
              <a:t>A</a:t>
            </a:r>
            <a:endParaRPr lang="fr-FR" altLang="fr-FR" sz="1200" dirty="0"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kumimoji="0" lang="fr-FR" altLang="fr-FR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lang="fr-FR" altLang="fr-FR" sz="1200" dirty="0"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kumimoji="0" lang="fr-FR" altLang="fr-FR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lang="fr-FR" altLang="fr-FR" sz="1200" dirty="0"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kumimoji="0" lang="fr-FR" altLang="fr-FR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lang="fr-FR" altLang="fr-FR" sz="1200" dirty="0"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kumimoji="0" lang="fr-FR" altLang="fr-FR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lang="fr-FR" altLang="fr-FR" sz="1200" dirty="0"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6403584"/>
            <a:ext cx="755967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fr-FR" altLang="fr-F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endParaRPr kumimoji="0" lang="fr-FR" alt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fr-FR" altLang="fr-F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	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14861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cid:image001.png@01D9715D.05AD21F0"/>
          <p:cNvPicPr>
            <a:picLocks noChangeAspect="1" noChangeArrowheads="1"/>
          </p:cNvPicPr>
          <p:nvPr/>
        </p:nvPicPr>
        <p:blipFill>
          <a:blip r:embed="rId2" r:link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564104"/>
            <a:ext cx="3838575" cy="3838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17" name="Picture 1" descr="cid:image002.png@01D9715D.05AD21F0"/>
          <p:cNvPicPr>
            <a:picLocks noChangeAspect="1" noChangeArrowheads="1"/>
          </p:cNvPicPr>
          <p:nvPr/>
        </p:nvPicPr>
        <p:blipFill>
          <a:blip r:embed="rId4" r:link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859879"/>
            <a:ext cx="5486400" cy="274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3"/>
          <p:cNvSpPr>
            <a:spLocks noChangeArrowheads="1"/>
          </p:cNvSpPr>
          <p:nvPr/>
        </p:nvSpPr>
        <p:spPr bwMode="auto">
          <a:xfrm>
            <a:off x="0" y="804590"/>
            <a:ext cx="7441461" cy="10618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</a:t>
            </a: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4</a:t>
            </a:r>
            <a:r>
              <a:rPr kumimoji="0" lang="en-US" altLang="fr-F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Treatments. </a:t>
            </a: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: MCA projection of the various treatments administered on dimensions 1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(x-axis) and 2 (y-axis). B: Sankey plot showing the association between treatment administered and, respectively,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en-US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ge and symptoms. </a:t>
            </a:r>
            <a:endParaRPr kumimoji="0" lang="fr-FR" alt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fr-FR" altLang="fr-F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endParaRPr kumimoji="0" lang="fr-FR" alt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Rectangle 4"/>
          <p:cNvSpPr>
            <a:spLocks noChangeArrowheads="1"/>
          </p:cNvSpPr>
          <p:nvPr/>
        </p:nvSpPr>
        <p:spPr bwMode="auto">
          <a:xfrm>
            <a:off x="0" y="5402679"/>
            <a:ext cx="755967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36449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r>
              <a:rPr kumimoji="0" lang="fr-FR" altLang="fr-FR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endParaRPr kumimoji="0" lang="fr-FR" altLang="fr-FR" sz="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644900" algn="l"/>
              </a:tabLst>
            </a:pP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Rectangle 5"/>
          <p:cNvSpPr>
            <a:spLocks noChangeArrowheads="1"/>
          </p:cNvSpPr>
          <p:nvPr/>
        </p:nvSpPr>
        <p:spPr bwMode="auto">
          <a:xfrm>
            <a:off x="0" y="8603079"/>
            <a:ext cx="755967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93224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</TotalTime>
  <Words>779</Words>
  <Application>Microsoft Office PowerPoint</Application>
  <PresentationFormat>Personnalisé</PresentationFormat>
  <Paragraphs>229</Paragraphs>
  <Slides>9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Thème Office</vt:lpstr>
      <vt:lpstr>Unknown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ECONO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oumet</dc:creator>
  <cp:lastModifiedBy>Choumet</cp:lastModifiedBy>
  <cp:revision>4</cp:revision>
  <dcterms:created xsi:type="dcterms:W3CDTF">2023-09-08T13:39:25Z</dcterms:created>
  <dcterms:modified xsi:type="dcterms:W3CDTF">2023-12-18T18:28:06Z</dcterms:modified>
</cp:coreProperties>
</file>